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CF94E8-2F0A-4E07-B1FD-3B87B54E641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FDB69-7AD7-402E-BA22-809AE98AED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F418E7-8D78-41DE-9A1B-99214ECD53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23CA7C-ECB7-4396-BD14-D04BB46A67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3CBE13-0067-4735-A02E-FA32976EBA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42D396-24DB-429F-B26E-791A64670A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A41BF-C54D-4091-954B-D923FB63BA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B255ED-CD43-4934-8EEE-C02016E8A5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363947-7C89-4A8A-9220-28927FFE20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61FD3-CF54-4DEE-9A4C-4711DA42D5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159655-21CF-4245-95A0-F2093A96BB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641CB7-5367-4A14-9A87-942CA7212B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40147E-6226-43B6-9152-43D24F9CCD82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4F91AF-F4C8-453C-9B61-AB234C0C241D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7" descr="M:\PhD M.Leite\AnxA1\Article and Presentations\Intensity and Percentage.jpg"/>
          <p:cNvPicPr/>
          <p:nvPr/>
        </p:nvPicPr>
        <p:blipFill>
          <a:blip r:embed="rId1"/>
          <a:stretch/>
        </p:blipFill>
        <p:spPr>
          <a:xfrm>
            <a:off x="635040" y="2066760"/>
            <a:ext cx="2486160" cy="21765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8" descr="M:\PhD M.Leite\AnxA1\Article and Presentations\Location and Percentage.jpg"/>
          <p:cNvPicPr/>
          <p:nvPr/>
        </p:nvPicPr>
        <p:blipFill>
          <a:blip r:embed="rId2"/>
          <a:stretch/>
        </p:blipFill>
        <p:spPr>
          <a:xfrm>
            <a:off x="3703680" y="2031840"/>
            <a:ext cx="2486160" cy="217656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2" descr="M:\PhD M.Leite\AnxA1\Article and Presentations\KM curves for article\Expression OS.tif"/>
          <p:cNvPicPr/>
          <p:nvPr/>
        </p:nvPicPr>
        <p:blipFill>
          <a:blip r:embed="rId3"/>
          <a:srcRect l="11317" t="5535" r="4155" b="25322"/>
          <a:stretch/>
        </p:blipFill>
        <p:spPr>
          <a:xfrm>
            <a:off x="260280" y="4356000"/>
            <a:ext cx="3024360" cy="180036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3" descr="M:\PhD M.Leite\AnxA1\Article and Presentations\KM curves for article\Expression BCSS.tif"/>
          <p:cNvPicPr/>
          <p:nvPr/>
        </p:nvPicPr>
        <p:blipFill>
          <a:blip r:embed="rId4"/>
          <a:srcRect l="12081" t="5535" r="3390" b="25322"/>
          <a:stretch/>
        </p:blipFill>
        <p:spPr>
          <a:xfrm>
            <a:off x="3348000" y="4356000"/>
            <a:ext cx="3024360" cy="1800360"/>
          </a:xfrm>
          <a:prstGeom prst="rect">
            <a:avLst/>
          </a:prstGeom>
          <a:ln w="0">
            <a:noFill/>
          </a:ln>
        </p:spPr>
      </p:pic>
      <p:sp>
        <p:nvSpPr>
          <p:cNvPr id="45" name="TextBox 17"/>
          <p:cNvSpPr/>
          <p:nvPr/>
        </p:nvSpPr>
        <p:spPr>
          <a:xfrm>
            <a:off x="1839960" y="2201760"/>
            <a:ext cx="1000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0.207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eft Brace 8"/>
          <p:cNvSpPr/>
          <p:nvPr/>
        </p:nvSpPr>
        <p:spPr>
          <a:xfrm rot="5400000">
            <a:off x="2255760" y="2103480"/>
            <a:ext cx="185760" cy="719280"/>
          </a:xfrm>
          <a:custGeom>
            <a:avLst/>
            <a:gdLst>
              <a:gd name="textAreaLeft" fmla="*/ 118800 w 185760"/>
              <a:gd name="textAreaRight" fmla="*/ 186120 w 185760"/>
              <a:gd name="textAreaTop" fmla="*/ 23760 h 719280"/>
              <a:gd name="textAreaBottom" fmla="*/ 695520 h 7192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155"/>
                  <a:pt x="10800" y="2310"/>
                </a:cubicBezTo>
                <a:lnTo>
                  <a:pt x="10800" y="8490"/>
                </a:lnTo>
                <a:cubicBezTo>
                  <a:pt x="10800" y="9645"/>
                  <a:pt x="5400" y="10800"/>
                  <a:pt x="0" y="10800"/>
                </a:cubicBezTo>
                <a:cubicBezTo>
                  <a:pt x="5400" y="10800"/>
                  <a:pt x="10800" y="11955"/>
                  <a:pt x="10800" y="13110"/>
                </a:cubicBezTo>
                <a:lnTo>
                  <a:pt x="10800" y="19290"/>
                </a:lnTo>
                <a:cubicBezTo>
                  <a:pt x="10800" y="20445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7"/>
          <p:cNvSpPr/>
          <p:nvPr/>
        </p:nvSpPr>
        <p:spPr>
          <a:xfrm>
            <a:off x="1378080" y="1895400"/>
            <a:ext cx="1299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&lt; 0.000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eft Brace 10"/>
          <p:cNvSpPr/>
          <p:nvPr/>
        </p:nvSpPr>
        <p:spPr>
          <a:xfrm rot="5400000">
            <a:off x="1959120" y="1662120"/>
            <a:ext cx="204480" cy="1008000"/>
          </a:xfrm>
          <a:custGeom>
            <a:avLst/>
            <a:gdLst>
              <a:gd name="textAreaLeft" fmla="*/ 130680 w 204480"/>
              <a:gd name="textAreaRight" fmla="*/ 204840 w 204480"/>
              <a:gd name="textAreaTop" fmla="*/ 26280 h 1008000"/>
              <a:gd name="textAreaBottom" fmla="*/ 981720 h 1008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9"/>
                  <a:pt x="10800" y="1817"/>
                </a:cubicBezTo>
                <a:lnTo>
                  <a:pt x="10800" y="8983"/>
                </a:lnTo>
                <a:cubicBezTo>
                  <a:pt x="10800" y="9892"/>
                  <a:pt x="5400" y="10800"/>
                  <a:pt x="0" y="10800"/>
                </a:cubicBezTo>
                <a:cubicBezTo>
                  <a:pt x="5400" y="10800"/>
                  <a:pt x="10800" y="11709"/>
                  <a:pt x="10800" y="12617"/>
                </a:cubicBezTo>
                <a:lnTo>
                  <a:pt x="10800" y="19783"/>
                </a:lnTo>
                <a:cubicBezTo>
                  <a:pt x="10800" y="20692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7"/>
          <p:cNvSpPr/>
          <p:nvPr/>
        </p:nvSpPr>
        <p:spPr>
          <a:xfrm>
            <a:off x="4940280" y="3079440"/>
            <a:ext cx="1000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0.001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eft Brace 12"/>
          <p:cNvSpPr/>
          <p:nvPr/>
        </p:nvSpPr>
        <p:spPr>
          <a:xfrm rot="5400000">
            <a:off x="5357880" y="2979720"/>
            <a:ext cx="184320" cy="720720"/>
          </a:xfrm>
          <a:custGeom>
            <a:avLst/>
            <a:gdLst>
              <a:gd name="textAreaLeft" fmla="*/ 117720 w 184320"/>
              <a:gd name="textAreaRight" fmla="*/ 184680 w 184320"/>
              <a:gd name="textAreaTop" fmla="*/ 23760 h 720720"/>
              <a:gd name="textAreaBottom" fmla="*/ 696960 h 720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143"/>
                  <a:pt x="10800" y="2285"/>
                </a:cubicBezTo>
                <a:lnTo>
                  <a:pt x="10800" y="8515"/>
                </a:lnTo>
                <a:cubicBezTo>
                  <a:pt x="10800" y="9658"/>
                  <a:pt x="5400" y="10800"/>
                  <a:pt x="0" y="10800"/>
                </a:cubicBezTo>
                <a:cubicBezTo>
                  <a:pt x="5400" y="10800"/>
                  <a:pt x="10800" y="11943"/>
                  <a:pt x="10800" y="13085"/>
                </a:cubicBezTo>
                <a:lnTo>
                  <a:pt x="10800" y="19315"/>
                </a:lnTo>
                <a:cubicBezTo>
                  <a:pt x="10800" y="20458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7"/>
          <p:cNvSpPr/>
          <p:nvPr/>
        </p:nvSpPr>
        <p:spPr>
          <a:xfrm>
            <a:off x="4478400" y="2771640"/>
            <a:ext cx="1299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 0.587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eft Brace 14"/>
          <p:cNvSpPr/>
          <p:nvPr/>
        </p:nvSpPr>
        <p:spPr>
          <a:xfrm rot="5400000">
            <a:off x="5059080" y="2538360"/>
            <a:ext cx="191880" cy="995400"/>
          </a:xfrm>
          <a:custGeom>
            <a:avLst/>
            <a:gdLst>
              <a:gd name="textAreaLeft" fmla="*/ 122760 w 191880"/>
              <a:gd name="textAreaRight" fmla="*/ 192240 w 191880"/>
              <a:gd name="textAreaTop" fmla="*/ 24840 h 995400"/>
              <a:gd name="textAreaBottom" fmla="*/ 970560 h 9954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63"/>
                  <a:pt x="10800" y="1726"/>
                </a:cubicBezTo>
                <a:lnTo>
                  <a:pt x="10800" y="9074"/>
                </a:lnTo>
                <a:cubicBezTo>
                  <a:pt x="10800" y="9937"/>
                  <a:pt x="5400" y="10800"/>
                  <a:pt x="0" y="10800"/>
                </a:cubicBezTo>
                <a:cubicBezTo>
                  <a:pt x="5400" y="10800"/>
                  <a:pt x="10800" y="11663"/>
                  <a:pt x="10800" y="12526"/>
                </a:cubicBezTo>
                <a:lnTo>
                  <a:pt x="10800" y="19874"/>
                </a:lnTo>
                <a:cubicBezTo>
                  <a:pt x="10800" y="20737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7"/>
          <p:cNvSpPr/>
          <p:nvPr/>
        </p:nvSpPr>
        <p:spPr>
          <a:xfrm>
            <a:off x="1052640" y="4087440"/>
            <a:ext cx="187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XA1 percentage leve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7"/>
          <p:cNvSpPr/>
          <p:nvPr/>
        </p:nvSpPr>
        <p:spPr>
          <a:xfrm>
            <a:off x="4140360" y="4086360"/>
            <a:ext cx="1873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XA1 percentage level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6"/>
          <p:cNvSpPr/>
          <p:nvPr/>
        </p:nvSpPr>
        <p:spPr>
          <a:xfrm>
            <a:off x="404640" y="205092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6"/>
          <p:cNvSpPr/>
          <p:nvPr/>
        </p:nvSpPr>
        <p:spPr>
          <a:xfrm>
            <a:off x="3495600" y="205092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6"/>
          <p:cNvSpPr/>
          <p:nvPr/>
        </p:nvSpPr>
        <p:spPr>
          <a:xfrm>
            <a:off x="406440" y="415116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6"/>
          <p:cNvSpPr/>
          <p:nvPr/>
        </p:nvSpPr>
        <p:spPr>
          <a:xfrm>
            <a:off x="3495600" y="4156200"/>
            <a:ext cx="285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17"/>
          <p:cNvSpPr/>
          <p:nvPr/>
        </p:nvSpPr>
        <p:spPr>
          <a:xfrm>
            <a:off x="1095480" y="519912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47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17"/>
          <p:cNvSpPr/>
          <p:nvPr/>
        </p:nvSpPr>
        <p:spPr>
          <a:xfrm>
            <a:off x="1084320" y="532908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23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17"/>
          <p:cNvSpPr/>
          <p:nvPr/>
        </p:nvSpPr>
        <p:spPr>
          <a:xfrm>
            <a:off x="1084320" y="544824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1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7"/>
          <p:cNvSpPr/>
          <p:nvPr/>
        </p:nvSpPr>
        <p:spPr>
          <a:xfrm>
            <a:off x="1084320" y="557388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55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eft Brace 25"/>
          <p:cNvSpPr/>
          <p:nvPr/>
        </p:nvSpPr>
        <p:spPr>
          <a:xfrm rot="10800000">
            <a:off x="1674360" y="5297400"/>
            <a:ext cx="71640" cy="216000"/>
          </a:xfrm>
          <a:custGeom>
            <a:avLst/>
            <a:gdLst>
              <a:gd name="textAreaLeft" fmla="*/ 45720 w 71640"/>
              <a:gd name="textAreaRight" fmla="*/ 72000 w 71640"/>
              <a:gd name="textAreaTop" fmla="*/ 9000 h 216000"/>
              <a:gd name="textAreaBottom" fmla="*/ 207000 h 216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480"/>
                  <a:pt x="10800" y="2959"/>
                </a:cubicBezTo>
                <a:lnTo>
                  <a:pt x="10800" y="7841"/>
                </a:lnTo>
                <a:cubicBezTo>
                  <a:pt x="10800" y="9321"/>
                  <a:pt x="5400" y="10800"/>
                  <a:pt x="0" y="10800"/>
                </a:cubicBezTo>
                <a:cubicBezTo>
                  <a:pt x="5400" y="10800"/>
                  <a:pt x="10800" y="12280"/>
                  <a:pt x="10800" y="13759"/>
                </a:cubicBezTo>
                <a:lnTo>
                  <a:pt x="10800" y="18641"/>
                </a:lnTo>
                <a:cubicBezTo>
                  <a:pt x="10800" y="2012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eft Brace 26"/>
          <p:cNvSpPr/>
          <p:nvPr/>
        </p:nvSpPr>
        <p:spPr>
          <a:xfrm rot="10800000">
            <a:off x="1674360" y="5545080"/>
            <a:ext cx="71640" cy="216000"/>
          </a:xfrm>
          <a:custGeom>
            <a:avLst/>
            <a:gdLst>
              <a:gd name="textAreaLeft" fmla="*/ 45720 w 71640"/>
              <a:gd name="textAreaRight" fmla="*/ 72000 w 71640"/>
              <a:gd name="textAreaTop" fmla="*/ 9000 h 216000"/>
              <a:gd name="textAreaBottom" fmla="*/ 207000 h 216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480"/>
                  <a:pt x="10800" y="2959"/>
                </a:cubicBezTo>
                <a:lnTo>
                  <a:pt x="10800" y="7841"/>
                </a:lnTo>
                <a:cubicBezTo>
                  <a:pt x="10800" y="9321"/>
                  <a:pt x="5400" y="10800"/>
                  <a:pt x="0" y="10800"/>
                </a:cubicBezTo>
                <a:cubicBezTo>
                  <a:pt x="5400" y="10800"/>
                  <a:pt x="10800" y="12280"/>
                  <a:pt x="10800" y="13759"/>
                </a:cubicBezTo>
                <a:lnTo>
                  <a:pt x="10800" y="18641"/>
                </a:lnTo>
                <a:cubicBezTo>
                  <a:pt x="10800" y="2012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17"/>
          <p:cNvSpPr/>
          <p:nvPr/>
        </p:nvSpPr>
        <p:spPr>
          <a:xfrm>
            <a:off x="1689120" y="5272560"/>
            <a:ext cx="568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=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0.915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7"/>
          <p:cNvSpPr/>
          <p:nvPr/>
        </p:nvSpPr>
        <p:spPr>
          <a:xfrm>
            <a:off x="1690560" y="5513040"/>
            <a:ext cx="568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=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0.08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17"/>
          <p:cNvSpPr/>
          <p:nvPr/>
        </p:nvSpPr>
        <p:spPr>
          <a:xfrm>
            <a:off x="4151160" y="5207040"/>
            <a:ext cx="10004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 = 47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7"/>
          <p:cNvSpPr/>
          <p:nvPr/>
        </p:nvSpPr>
        <p:spPr>
          <a:xfrm>
            <a:off x="4138560" y="533700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23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17"/>
          <p:cNvSpPr/>
          <p:nvPr/>
        </p:nvSpPr>
        <p:spPr>
          <a:xfrm>
            <a:off x="4138560" y="545616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15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17"/>
          <p:cNvSpPr/>
          <p:nvPr/>
        </p:nvSpPr>
        <p:spPr>
          <a:xfrm>
            <a:off x="4138560" y="5582520"/>
            <a:ext cx="10000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0" lang="en-US" sz="7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n = 55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eft Brace 33"/>
          <p:cNvSpPr/>
          <p:nvPr/>
        </p:nvSpPr>
        <p:spPr>
          <a:xfrm rot="10800000">
            <a:off x="4730760" y="5305320"/>
            <a:ext cx="71280" cy="216000"/>
          </a:xfrm>
          <a:custGeom>
            <a:avLst/>
            <a:gdLst>
              <a:gd name="textAreaLeft" fmla="*/ 45720 w 71280"/>
              <a:gd name="textAreaRight" fmla="*/ 71640 w 71280"/>
              <a:gd name="textAreaTop" fmla="*/ 9000 h 216000"/>
              <a:gd name="textAreaBottom" fmla="*/ 207000 h 216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480"/>
                  <a:pt x="10800" y="2959"/>
                </a:cubicBezTo>
                <a:lnTo>
                  <a:pt x="10800" y="7841"/>
                </a:lnTo>
                <a:cubicBezTo>
                  <a:pt x="10800" y="9321"/>
                  <a:pt x="5400" y="10800"/>
                  <a:pt x="0" y="10800"/>
                </a:cubicBezTo>
                <a:cubicBezTo>
                  <a:pt x="5400" y="10800"/>
                  <a:pt x="10800" y="12280"/>
                  <a:pt x="10800" y="13759"/>
                </a:cubicBezTo>
                <a:lnTo>
                  <a:pt x="10800" y="18641"/>
                </a:lnTo>
                <a:cubicBezTo>
                  <a:pt x="10800" y="2012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eft Brace 34"/>
          <p:cNvSpPr/>
          <p:nvPr/>
        </p:nvSpPr>
        <p:spPr>
          <a:xfrm rot="10800000">
            <a:off x="4730760" y="5553000"/>
            <a:ext cx="71280" cy="216000"/>
          </a:xfrm>
          <a:custGeom>
            <a:avLst/>
            <a:gdLst>
              <a:gd name="textAreaLeft" fmla="*/ 45720 w 71280"/>
              <a:gd name="textAreaRight" fmla="*/ 71640 w 71280"/>
              <a:gd name="textAreaTop" fmla="*/ 9000 h 216000"/>
              <a:gd name="textAreaBottom" fmla="*/ 207000 h 2160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480"/>
                  <a:pt x="10800" y="2959"/>
                </a:cubicBezTo>
                <a:lnTo>
                  <a:pt x="10800" y="7841"/>
                </a:lnTo>
                <a:cubicBezTo>
                  <a:pt x="10800" y="9321"/>
                  <a:pt x="5400" y="10800"/>
                  <a:pt x="0" y="10800"/>
                </a:cubicBezTo>
                <a:cubicBezTo>
                  <a:pt x="5400" y="10800"/>
                  <a:pt x="10800" y="12280"/>
                  <a:pt x="10800" y="13759"/>
                </a:cubicBezTo>
                <a:lnTo>
                  <a:pt x="10800" y="18641"/>
                </a:lnTo>
                <a:cubicBezTo>
                  <a:pt x="10800" y="20121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7"/>
          <p:cNvSpPr/>
          <p:nvPr/>
        </p:nvSpPr>
        <p:spPr>
          <a:xfrm>
            <a:off x="4745160" y="5281200"/>
            <a:ext cx="568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=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0.15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7"/>
          <p:cNvSpPr/>
          <p:nvPr/>
        </p:nvSpPr>
        <p:spPr>
          <a:xfrm>
            <a:off x="4746600" y="5520960"/>
            <a:ext cx="568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=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0.08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9"/>
          <p:cNvSpPr/>
          <p:nvPr/>
        </p:nvSpPr>
        <p:spPr>
          <a:xfrm>
            <a:off x="404640" y="6173640"/>
            <a:ext cx="60487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rcentage of  patients with a tumor with moderate to strong intensity of staining versus the tumor percentage levels of ANXA1 0 (0%); 1+ (10-30%); 2+ (40-70%); 3+ (80-100%)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for those with staining only in cytoplasm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Survival according to ANXA1 percentage levels: Overall Survival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Breast cancer Specific Survival </a:t>
            </a: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D)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4"/>
          <p:cNvSpPr/>
          <p:nvPr/>
        </p:nvSpPr>
        <p:spPr>
          <a:xfrm rot="16200000">
            <a:off x="-108720" y="2961360"/>
            <a:ext cx="18018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derate or strong stain (95%CI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14"/>
          <p:cNvSpPr/>
          <p:nvPr/>
        </p:nvSpPr>
        <p:spPr>
          <a:xfrm rot="16200000">
            <a:off x="2989080" y="2934000"/>
            <a:ext cx="1800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nly cytoplasm stain (95%CI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7:30Z</dcterms:modified>
  <cp:revision>413</cp:revision>
  <dc:subject/>
  <dc:title>Slide 1</dc:title>
</cp:coreProperties>
</file>